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3" r:id="rId2"/>
    <p:sldId id="286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2"/>
    <p:restoredTop sz="94691"/>
  </p:normalViewPr>
  <p:slideViewPr>
    <p:cSldViewPr snapToGrid="0">
      <p:cViewPr varScale="1">
        <p:scale>
          <a:sx n="69" d="100"/>
          <a:sy n="69" d="100"/>
        </p:scale>
        <p:origin x="34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2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879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333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247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351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79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195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089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028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993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971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0B70D7-892B-0641-AA6E-87A1DD85ABE3}" type="datetimeFigureOut">
              <a:rPr lang="en-US" smtClean="0"/>
              <a:t>12/3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AE9EAD-C65F-2C42-9401-AF1642D1F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187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A5588DC-D027-F29B-FEEE-4FFAC72866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1066800"/>
            <a:ext cx="5029200" cy="10058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D969C64-62CF-8C6B-713D-9C1502B1875B}"/>
              </a:ext>
            </a:extLst>
          </p:cNvPr>
          <p:cNvSpPr txBox="1"/>
          <p:nvPr/>
        </p:nvSpPr>
        <p:spPr>
          <a:xfrm>
            <a:off x="1" y="64595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177CB2-E677-85E1-B3EB-F12791DF49A3}"/>
              </a:ext>
            </a:extLst>
          </p:cNvPr>
          <p:cNvSpPr txBox="1"/>
          <p:nvPr/>
        </p:nvSpPr>
        <p:spPr>
          <a:xfrm rot="16200000">
            <a:off x="-224221" y="5942111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Lev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922EB2-E1E1-748B-A634-9D882812E537}"/>
              </a:ext>
            </a:extLst>
          </p:cNvPr>
          <p:cNvSpPr txBox="1"/>
          <p:nvPr/>
        </p:nvSpPr>
        <p:spPr>
          <a:xfrm>
            <a:off x="550190" y="107192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32734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4F25A0D-EB3B-E1DE-7EEC-7B6C7C40F53E}"/>
              </a:ext>
            </a:extLst>
          </p:cNvPr>
          <p:cNvSpPr txBox="1"/>
          <p:nvPr/>
        </p:nvSpPr>
        <p:spPr>
          <a:xfrm rot="16200000">
            <a:off x="-286214" y="3958327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Leve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24AE43-4033-8096-037D-383519C3DFB2}"/>
              </a:ext>
            </a:extLst>
          </p:cNvPr>
          <p:cNvSpPr txBox="1"/>
          <p:nvPr/>
        </p:nvSpPr>
        <p:spPr>
          <a:xfrm>
            <a:off x="554294" y="9928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BB7217-53DD-27F5-74A8-B6A9F2B291B7}"/>
              </a:ext>
            </a:extLst>
          </p:cNvPr>
          <p:cNvSpPr txBox="1"/>
          <p:nvPr/>
        </p:nvSpPr>
        <p:spPr>
          <a:xfrm>
            <a:off x="3205934" y="9928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 descr="A diagram of a variety of numbers&#10;&#10;Description automatically generated with medium confidence">
            <a:extLst>
              <a:ext uri="{FF2B5EF4-FFF2-40B4-BE49-F238E27FC236}">
                <a16:creationId xmlns:a16="http://schemas.microsoft.com/office/drawing/2014/main" id="{63D32924-70C4-DEA5-9E17-E9D147EB19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0617" y="1142766"/>
            <a:ext cx="2514029" cy="10105002"/>
          </a:xfrm>
          <a:prstGeom prst="rect">
            <a:avLst/>
          </a:prstGeom>
        </p:spPr>
      </p:pic>
      <p:pic>
        <p:nvPicPr>
          <p:cNvPr id="5" name="Picture 4" descr="A graph of different types of plants&#10;&#10;Description automatically generated with medium confidence">
            <a:extLst>
              <a:ext uri="{FF2B5EF4-FFF2-40B4-BE49-F238E27FC236}">
                <a16:creationId xmlns:a16="http://schemas.microsoft.com/office/drawing/2014/main" id="{5F36F93B-668A-2D0E-B002-3990EB517B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1207" y="1164602"/>
            <a:ext cx="2516368" cy="57876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CC1B159-0ED8-7CCE-83DB-DA3D67542B69}"/>
              </a:ext>
            </a:extLst>
          </p:cNvPr>
          <p:cNvSpPr txBox="1"/>
          <p:nvPr/>
        </p:nvSpPr>
        <p:spPr>
          <a:xfrm>
            <a:off x="1" y="630233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9052BB4-369F-E8F2-4476-D4BFBB9C4799}"/>
              </a:ext>
            </a:extLst>
          </p:cNvPr>
          <p:cNvGraphicFramePr>
            <a:graphicFrameLocks noGrp="1"/>
          </p:cNvGraphicFramePr>
          <p:nvPr/>
        </p:nvGraphicFramePr>
        <p:xfrm>
          <a:off x="438594" y="7145527"/>
          <a:ext cx="2857500" cy="40481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922">
                  <a:extLst>
                    <a:ext uri="{9D8B030D-6E8A-4147-A177-3AD203B41FA5}">
                      <a16:colId xmlns:a16="http://schemas.microsoft.com/office/drawing/2014/main" val="1327398622"/>
                    </a:ext>
                  </a:extLst>
                </a:gridCol>
                <a:gridCol w="825922">
                  <a:extLst>
                    <a:ext uri="{9D8B030D-6E8A-4147-A177-3AD203B41FA5}">
                      <a16:colId xmlns:a16="http://schemas.microsoft.com/office/drawing/2014/main" val="613198028"/>
                    </a:ext>
                  </a:extLst>
                </a:gridCol>
                <a:gridCol w="1205656">
                  <a:extLst>
                    <a:ext uri="{9D8B030D-6E8A-4147-A177-3AD203B41FA5}">
                      <a16:colId xmlns:a16="http://schemas.microsoft.com/office/drawing/2014/main" val="532887542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6485772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pero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6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0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89198556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A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9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4747367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2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8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6957527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8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0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83394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D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9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48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061141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 (receptor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9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0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655102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r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5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6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129971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2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9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7986801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P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033332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6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3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881236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4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773128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y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5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9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595351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x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93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534751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u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1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4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442933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N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1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25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004194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5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309439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9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202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1483664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AR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5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434138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MB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4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1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9938206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RAS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3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5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13567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RB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2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1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0711626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ens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5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2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989583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ype lect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5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4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200337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rop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0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7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2073081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71EF807-A12B-926F-5A36-B6C0A92296DA}"/>
              </a:ext>
            </a:extLst>
          </p:cNvPr>
          <p:cNvSpPr txBox="1"/>
          <p:nvPr/>
        </p:nvSpPr>
        <p:spPr>
          <a:xfrm>
            <a:off x="540958" y="67761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07150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3</Words>
  <Application>Microsoft Macintosh PowerPoint</Application>
  <PresentationFormat>Widescreen</PresentationFormat>
  <Paragraphs>8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itzmeyer,Emily</dc:creator>
  <cp:lastModifiedBy>Fitzmeyer,Emily</cp:lastModifiedBy>
  <cp:revision>1</cp:revision>
  <dcterms:created xsi:type="dcterms:W3CDTF">2024-12-30T20:24:55Z</dcterms:created>
  <dcterms:modified xsi:type="dcterms:W3CDTF">2024-12-30T20:26:39Z</dcterms:modified>
</cp:coreProperties>
</file>